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312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05A9-A8D6-0F4F-AA97-E988BE7F743C}" type="datetimeFigureOut">
              <a:rPr lang="de-DE" smtClean="0"/>
              <a:t>29.06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00485-5501-204C-8116-0202B32D5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67649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05A9-A8D6-0F4F-AA97-E988BE7F743C}" type="datetimeFigureOut">
              <a:rPr lang="de-DE" smtClean="0"/>
              <a:t>29.06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00485-5501-204C-8116-0202B32D5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2392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05A9-A8D6-0F4F-AA97-E988BE7F743C}" type="datetimeFigureOut">
              <a:rPr lang="de-DE" smtClean="0"/>
              <a:t>29.06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00485-5501-204C-8116-0202B32D5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240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05A9-A8D6-0F4F-AA97-E988BE7F743C}" type="datetimeFigureOut">
              <a:rPr lang="de-DE" smtClean="0"/>
              <a:t>29.06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00485-5501-204C-8116-0202B32D5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0931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05A9-A8D6-0F4F-AA97-E988BE7F743C}" type="datetimeFigureOut">
              <a:rPr lang="de-DE" smtClean="0"/>
              <a:t>29.06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00485-5501-204C-8116-0202B32D5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60478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05A9-A8D6-0F4F-AA97-E988BE7F743C}" type="datetimeFigureOut">
              <a:rPr lang="de-DE" smtClean="0"/>
              <a:t>29.06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00485-5501-204C-8116-0202B32D5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9315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05A9-A8D6-0F4F-AA97-E988BE7F743C}" type="datetimeFigureOut">
              <a:rPr lang="de-DE" smtClean="0"/>
              <a:t>29.06.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00485-5501-204C-8116-0202B32D5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0748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05A9-A8D6-0F4F-AA97-E988BE7F743C}" type="datetimeFigureOut">
              <a:rPr lang="de-DE" smtClean="0"/>
              <a:t>29.06.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00485-5501-204C-8116-0202B32D5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5285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05A9-A8D6-0F4F-AA97-E988BE7F743C}" type="datetimeFigureOut">
              <a:rPr lang="de-DE" smtClean="0"/>
              <a:t>29.06.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00485-5501-204C-8116-0202B32D5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0613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05A9-A8D6-0F4F-AA97-E988BE7F743C}" type="datetimeFigureOut">
              <a:rPr lang="de-DE" smtClean="0"/>
              <a:t>29.06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00485-5501-204C-8116-0202B32D5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2440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05A9-A8D6-0F4F-AA97-E988BE7F743C}" type="datetimeFigureOut">
              <a:rPr lang="de-DE" smtClean="0"/>
              <a:t>29.06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00485-5501-204C-8116-0202B32D5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66996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6405A9-A8D6-0F4F-AA97-E988BE7F743C}" type="datetimeFigureOut">
              <a:rPr lang="de-DE" smtClean="0"/>
              <a:t>29.06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C00485-5501-204C-8116-0202B32D5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7907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99145" y="6077234"/>
            <a:ext cx="87849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Additional </a:t>
            </a:r>
            <a:r>
              <a:rPr lang="de-DE" sz="1200" b="1" dirty="0" err="1" smtClean="0"/>
              <a:t>file</a:t>
            </a:r>
            <a:r>
              <a:rPr lang="de-DE" sz="1200" b="1" dirty="0" smtClean="0"/>
              <a:t> 1:</a:t>
            </a:r>
            <a:r>
              <a:rPr lang="de-DE" sz="1200" dirty="0" smtClean="0"/>
              <a:t> </a:t>
            </a:r>
            <a:endParaRPr lang="de-DE" sz="1200" dirty="0" smtClean="0"/>
          </a:p>
          <a:p>
            <a:r>
              <a:rPr lang="de-DE" sz="1200" dirty="0" smtClean="0"/>
              <a:t>Distribution </a:t>
            </a:r>
            <a:r>
              <a:rPr lang="de-DE" sz="1200" dirty="0"/>
              <a:t>and frequency of GNB isolates in different clinical specimens</a:t>
            </a:r>
          </a:p>
        </p:txBody>
      </p:sp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6493984"/>
              </p:ext>
            </p:extLst>
          </p:nvPr>
        </p:nvGraphicFramePr>
        <p:xfrm>
          <a:off x="287016" y="188637"/>
          <a:ext cx="8784975" cy="5250567"/>
        </p:xfrm>
        <a:graphic>
          <a:graphicData uri="http://schemas.openxmlformats.org/drawingml/2006/table">
            <a:tbl>
              <a:tblPr/>
              <a:tblGrid>
                <a:gridCol w="1010661"/>
                <a:gridCol w="861547"/>
                <a:gridCol w="792088"/>
                <a:gridCol w="720080"/>
                <a:gridCol w="864096"/>
                <a:gridCol w="936104"/>
                <a:gridCol w="864096"/>
                <a:gridCol w="864096"/>
                <a:gridCol w="783804"/>
                <a:gridCol w="1088403"/>
              </a:tblGrid>
              <a:tr h="201127">
                <a:tc rowSpan="3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 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9"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Specimen Type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</a:tr>
              <a:tr h="75279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wound sample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urine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biopsy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OTHERS</a:t>
                      </a:r>
                      <a:r>
                        <a:rPr lang="en-GB" sz="1000" baseline="30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*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Total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1119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No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%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No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%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No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%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No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%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No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1119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E. coli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7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53.8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5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38.5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7.7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3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1119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K. pneumoniae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4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45.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32.3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6.5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5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6.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3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1119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E. cloacae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71.4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4.3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4.3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4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1119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A. </a:t>
                      </a:r>
                      <a:r>
                        <a:rPr lang="en-GB" sz="1000" i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baumanii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78.6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7.1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7.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7.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4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1119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P. aeruginosa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7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5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4.3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4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8.6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7.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4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1127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. morganii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33.3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66.7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3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1127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P. mirablis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5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3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75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4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1127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A. faecalis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66.7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33.3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3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1127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P. stuartii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4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4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5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1127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S. maltophilia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5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5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4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1127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K. oxytoca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0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1127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A. pitti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0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7384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B. </a:t>
                      </a:r>
                      <a:r>
                        <a:rPr lang="en-GB" sz="1000" i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bronchiseptica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0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1127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E. hermani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0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1127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A. haemolyticus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0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51676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Total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61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54.5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30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6.8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2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0.7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9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8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12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199145" y="5451815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* </a:t>
            </a:r>
            <a:r>
              <a:rPr kumimoji="0" lang="en-GB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includes throat swab, sputum, vaginal discharge &amp; eye discharge</a:t>
            </a:r>
            <a:endParaRPr kumimoji="0" lang="en-GB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7402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4</Words>
  <Application>Microsoft Macintosh PowerPoint</Application>
  <PresentationFormat>Bildschirmpräsentation (4:3)</PresentationFormat>
  <Paragraphs>179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-Design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hael Pritsch</dc:creator>
  <cp:lastModifiedBy>Michael Pritsch</cp:lastModifiedBy>
  <cp:revision>3</cp:revision>
  <dcterms:created xsi:type="dcterms:W3CDTF">2018-02-21T11:57:19Z</dcterms:created>
  <dcterms:modified xsi:type="dcterms:W3CDTF">2018-06-29T15:55:12Z</dcterms:modified>
</cp:coreProperties>
</file>